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jpeg" ContentType="image/jpeg"/>
  <Override PartName="/ppt/media/image3.png" ContentType="image/png"/>
  <Override PartName="/ppt/media/image4.png" ContentType="image/png"/>
  <Override PartName="/ppt/media/image8.jpeg" ContentType="image/jpeg"/>
  <Override PartName="/ppt/media/image5.pct" ContentType="image/x-pict"/>
  <Override PartName="/ppt/media/image6.png" ContentType="image/png"/>
  <Override PartName="/ppt/media/image7.png" ContentType="image/png"/>
  <Override PartName="/ppt/media/image9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584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584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B68E18B-66B1-4983-8E67-4C0C64ADCA07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Rectangle 7"/>
          <p:cNvSpPr/>
          <p:nvPr/>
        </p:nvSpPr>
        <p:spPr>
          <a:xfrm>
            <a:off x="388620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02A462E-DBC9-4F3D-84C8-511A718219B1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80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15F1AE-EB6A-4935-9F5E-BE34893DABA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95C938-D8A2-428A-92D8-E3E503B00B7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E3AD67-EF66-49A6-BC85-E432BEA0136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F8E14A-CA08-480F-B155-46B87FF88AC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927030-F834-44DF-87CE-BC73F6805E5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5935FB-B0A2-4625-942D-D287D83EB04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4905D0-4954-4705-8E68-44FAE72EDA4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640F79-A82B-4A14-9799-46292E2E0B6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8CB7DD-137D-4436-9BC0-733A592B553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8CC942-0125-44D3-9211-01923D9E25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F54143-F508-4F84-B8FD-AB89FA77FC7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57AC92-5262-4291-9092-522608D8C6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F85545B-BB94-4166-9FEA-0F420CB00ED1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ct"/><Relationship Id="rId6" Type="http://schemas.openxmlformats.org/officeDocument/2006/relationships/image" Target="../media/image5.pct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jpeg"/><Relationship Id="rId10" Type="http://schemas.openxmlformats.org/officeDocument/2006/relationships/image" Target="../media/image8.jpeg"/><Relationship Id="rId11" Type="http://schemas.openxmlformats.org/officeDocument/2006/relationships/image" Target="../media/image9.jpeg"/><Relationship Id="rId12" Type="http://schemas.openxmlformats.org/officeDocument/2006/relationships/image" Target="../media/image9.jpeg"/><Relationship Id="rId13" Type="http://schemas.openxmlformats.org/officeDocument/2006/relationships/slideLayout" Target="../slideLayouts/slideLayout1.xml"/><Relationship Id="rId1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19" descr="NOD 906 050309-3"/>
          <p:cNvPicPr/>
          <p:nvPr/>
        </p:nvPicPr>
        <p:blipFill>
          <a:blip r:embed="rId1"/>
          <a:srcRect l="0" t="18456" r="27691" b="7388"/>
          <a:stretch/>
        </p:blipFill>
        <p:spPr>
          <a:xfrm>
            <a:off x="3176640" y="1096920"/>
            <a:ext cx="1450800" cy="96372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21" descr="NOD 909 050309-3"/>
          <p:cNvPicPr/>
          <p:nvPr/>
        </p:nvPicPr>
        <p:blipFill>
          <a:blip r:embed="rId2">
            <a:lum contrast="30000"/>
          </a:blip>
          <a:srcRect l="13846" t="22161" r="5547" b="0"/>
          <a:stretch/>
        </p:blipFill>
        <p:spPr>
          <a:xfrm>
            <a:off x="3186000" y="2100240"/>
            <a:ext cx="1443240" cy="966960"/>
          </a:xfrm>
          <a:prstGeom prst="rect">
            <a:avLst/>
          </a:prstGeom>
          <a:ln w="0">
            <a:noFill/>
          </a:ln>
        </p:spPr>
      </p:pic>
      <p:sp>
        <p:nvSpPr>
          <p:cNvPr id="50" name="Text Box 22"/>
          <p:cNvSpPr/>
          <p:nvPr/>
        </p:nvSpPr>
        <p:spPr>
          <a:xfrm>
            <a:off x="3139560" y="814320"/>
            <a:ext cx="1518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Ponesimod: 13-wk-old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Picture 23" descr="NOD 910 050309-5"/>
          <p:cNvPicPr/>
          <p:nvPr/>
        </p:nvPicPr>
        <p:blipFill>
          <a:blip r:embed="rId3"/>
          <a:srcRect l="13836" t="0" r="19380" b="36914"/>
          <a:stretch/>
        </p:blipFill>
        <p:spPr>
          <a:xfrm>
            <a:off x="6597720" y="1095480"/>
            <a:ext cx="1428840" cy="96048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25" descr="NOD 910 050309-2"/>
          <p:cNvPicPr/>
          <p:nvPr/>
        </p:nvPicPr>
        <p:blipFill>
          <a:blip r:embed="rId4"/>
          <a:srcRect l="8311" t="22142" r="22152" b="11083"/>
          <a:stretch/>
        </p:blipFill>
        <p:spPr>
          <a:xfrm>
            <a:off x="6603840" y="2104920"/>
            <a:ext cx="1430640" cy="963720"/>
          </a:xfrm>
          <a:prstGeom prst="rect">
            <a:avLst/>
          </a:prstGeom>
          <a:ln w="0">
            <a:noFill/>
          </a:ln>
        </p:spPr>
      </p:pic>
      <p:sp>
        <p:nvSpPr>
          <p:cNvPr id="53" name="Text Box 26"/>
          <p:cNvSpPr/>
          <p:nvPr/>
        </p:nvSpPr>
        <p:spPr>
          <a:xfrm>
            <a:off x="6558840" y="814320"/>
            <a:ext cx="1518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Ponesimod: 35-wk-old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302"/>
          <p:cNvSpPr/>
          <p:nvPr/>
        </p:nvSpPr>
        <p:spPr>
          <a:xfrm>
            <a:off x="1450800" y="5106960"/>
            <a:ext cx="6685200" cy="9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Supplementary Figure S1: Monitoring of insulitis.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Ponesimod, mixed to regular food regimen, was administered to 6-week-old NOD mice up to 35 weeks of age. Pancreata were recovered at 13 and 35 weeks of age and formadehyde-fixed or frozen. (A) Paraffin sections were stained with eosin/hematoxylin. (B) Frozen sections were stained with anti-insulin and anti-CD3 antibodies. Untreated pre-diabetic (13 week old) or diabetic NOD mice were used as controls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28"/>
          <p:cNvSpPr/>
          <p:nvPr/>
        </p:nvSpPr>
        <p:spPr>
          <a:xfrm>
            <a:off x="5630760" y="6124680"/>
            <a:ext cx="298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1 (S. You et al.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30"/>
          <p:cNvSpPr/>
          <p:nvPr/>
        </p:nvSpPr>
        <p:spPr>
          <a:xfrm>
            <a:off x="1587600" y="814320"/>
            <a:ext cx="1471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Untreated: 13-wk-old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7" name="Picture 31" descr=""/>
          <p:cNvPicPr/>
          <p:nvPr/>
        </p:nvPicPr>
        <p:blipFill>
          <a:blip r:embed="rId5"/>
          <a:srcRect l="0" t="390637" r="0" b="0"/>
          <a:stretch/>
        </p:blipFill>
        <p:spPr>
          <a:xfrm>
            <a:off x="1585800" y="2103480"/>
            <a:ext cx="1451160" cy="96660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32" descr=""/>
          <p:cNvPicPr/>
          <p:nvPr/>
        </p:nvPicPr>
        <p:blipFill>
          <a:blip r:embed="rId6"/>
          <a:srcRect l="0" t="0" r="195317" b="0"/>
          <a:stretch/>
        </p:blipFill>
        <p:spPr>
          <a:xfrm>
            <a:off x="1579680" y="1089000"/>
            <a:ext cx="1454040" cy="966960"/>
          </a:xfrm>
          <a:prstGeom prst="rect">
            <a:avLst/>
          </a:prstGeom>
          <a:ln w="0">
            <a:noFill/>
          </a:ln>
        </p:spPr>
      </p:pic>
      <p:pic>
        <p:nvPicPr>
          <p:cNvPr id="59" name="Picture 33" descr="NOC CTRL Db 050309"/>
          <p:cNvPicPr/>
          <p:nvPr/>
        </p:nvPicPr>
        <p:blipFill>
          <a:blip r:embed="rId7"/>
          <a:srcRect l="2771" t="0" r="55372" b="47987"/>
          <a:stretch/>
        </p:blipFill>
        <p:spPr>
          <a:xfrm>
            <a:off x="5062680" y="1100160"/>
            <a:ext cx="1428480" cy="947880"/>
          </a:xfrm>
          <a:prstGeom prst="rect">
            <a:avLst/>
          </a:prstGeom>
          <a:ln w="0">
            <a:noFill/>
          </a:ln>
        </p:spPr>
      </p:pic>
      <p:pic>
        <p:nvPicPr>
          <p:cNvPr id="60" name="Picture 34" descr="NOC CTRL Db 050309"/>
          <p:cNvPicPr/>
          <p:nvPr/>
        </p:nvPicPr>
        <p:blipFill>
          <a:blip r:embed="rId8"/>
          <a:srcRect l="35993" t="44301" r="13843" b="3695"/>
          <a:stretch/>
        </p:blipFill>
        <p:spPr>
          <a:xfrm>
            <a:off x="5062680" y="2104920"/>
            <a:ext cx="1434960" cy="959040"/>
          </a:xfrm>
          <a:prstGeom prst="rect">
            <a:avLst/>
          </a:prstGeom>
          <a:ln w="0">
            <a:noFill/>
          </a:ln>
        </p:spPr>
      </p:pic>
      <p:sp>
        <p:nvSpPr>
          <p:cNvPr id="61" name="Text Box 35"/>
          <p:cNvSpPr/>
          <p:nvPr/>
        </p:nvSpPr>
        <p:spPr>
          <a:xfrm>
            <a:off x="5437080" y="814320"/>
            <a:ext cx="6807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Diabeti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36"/>
          <p:cNvSpPr/>
          <p:nvPr/>
        </p:nvSpPr>
        <p:spPr>
          <a:xfrm>
            <a:off x="1283400" y="669960"/>
            <a:ext cx="352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A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3" name="Group 43"/>
          <p:cNvGrpSpPr/>
          <p:nvPr/>
        </p:nvGrpSpPr>
        <p:grpSpPr>
          <a:xfrm>
            <a:off x="5070600" y="3720960"/>
            <a:ext cx="2999880" cy="1065240"/>
            <a:chOff x="5070600" y="3720960"/>
            <a:chExt cx="2999880" cy="1065240"/>
          </a:xfrm>
        </p:grpSpPr>
        <p:pic>
          <p:nvPicPr>
            <p:cNvPr id="64" name="Picture 12" descr="C:\Documents and Settings\Chantal K\Bureau\pancreas OM 20100715\insulin CD3 FoxP3\OM174 35sem\OM174-3 3b.jpg"/>
            <p:cNvPicPr/>
            <p:nvPr/>
          </p:nvPicPr>
          <p:blipFill>
            <a:blip r:embed="rId9">
              <a:lum bright="-8000"/>
            </a:blip>
            <a:srcRect l="0" t="0" r="75184" b="0"/>
            <a:stretch/>
          </p:blipFill>
          <p:spPr>
            <a:xfrm>
              <a:off x="5070600" y="3720960"/>
              <a:ext cx="990720" cy="1065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5" name="Picture 12" descr="C:\Documents and Settings\Chantal K\Bureau\pancreas OM 20100715\insulin CD3 FoxP3\OM174 35sem\OM174-3 3b.jpg"/>
            <p:cNvPicPr/>
            <p:nvPr/>
          </p:nvPicPr>
          <p:blipFill>
            <a:blip r:embed="rId10">
              <a:lum bright="-8000"/>
            </a:blip>
            <a:srcRect l="49592" t="0" r="0" b="0"/>
            <a:stretch/>
          </p:blipFill>
          <p:spPr>
            <a:xfrm>
              <a:off x="6058800" y="3720960"/>
              <a:ext cx="2011680" cy="106524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66" name="Group 49"/>
          <p:cNvGrpSpPr/>
          <p:nvPr/>
        </p:nvGrpSpPr>
        <p:grpSpPr>
          <a:xfrm>
            <a:off x="1582560" y="3724200"/>
            <a:ext cx="3090600" cy="1067040"/>
            <a:chOff x="1582560" y="3724200"/>
            <a:chExt cx="3090600" cy="1067040"/>
          </a:xfrm>
        </p:grpSpPr>
        <p:pic>
          <p:nvPicPr>
            <p:cNvPr id="67" name="Picture 14" descr="C:\Documents and Settings\Chantal K\Bureau\pancreas OM 20100715\insulin CD3 FoxP3\OM174 35sem\OM174-3 4b.jpg"/>
            <p:cNvPicPr/>
            <p:nvPr/>
          </p:nvPicPr>
          <p:blipFill>
            <a:blip r:embed="rId11">
              <a:lum bright="-20000"/>
            </a:blip>
            <a:srcRect l="49586" t="0" r="0" b="0"/>
            <a:stretch/>
          </p:blipFill>
          <p:spPr>
            <a:xfrm>
              <a:off x="2592720" y="3724200"/>
              <a:ext cx="2080440" cy="1067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8" name="Picture 14" descr="C:\Documents and Settings\Chantal K\Bureau\pancreas OM 20100715\insulin CD3 FoxP3\OM174 35sem\OM174-3 4b.jpg"/>
            <p:cNvPicPr/>
            <p:nvPr/>
          </p:nvPicPr>
          <p:blipFill>
            <a:blip r:embed="rId12">
              <a:lum bright="-20000"/>
            </a:blip>
            <a:srcRect l="0" t="0" r="75185" b="0"/>
            <a:stretch/>
          </p:blipFill>
          <p:spPr>
            <a:xfrm>
              <a:off x="1582560" y="3724200"/>
              <a:ext cx="1024560" cy="106704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69" name="Text Box 50"/>
          <p:cNvSpPr/>
          <p:nvPr/>
        </p:nvSpPr>
        <p:spPr>
          <a:xfrm>
            <a:off x="5811120" y="3286080"/>
            <a:ext cx="1518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Ponesimod: 35-wk-old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51"/>
          <p:cNvSpPr/>
          <p:nvPr/>
        </p:nvSpPr>
        <p:spPr>
          <a:xfrm>
            <a:off x="2457360" y="3286080"/>
            <a:ext cx="1343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Diabetic NOD mic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52"/>
          <p:cNvSpPr/>
          <p:nvPr/>
        </p:nvSpPr>
        <p:spPr>
          <a:xfrm>
            <a:off x="1283040" y="3205080"/>
            <a:ext cx="343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B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53"/>
          <p:cNvSpPr/>
          <p:nvPr/>
        </p:nvSpPr>
        <p:spPr>
          <a:xfrm>
            <a:off x="1861920" y="3517920"/>
            <a:ext cx="397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fr-FR" sz="9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CD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54"/>
          <p:cNvSpPr/>
          <p:nvPr/>
        </p:nvSpPr>
        <p:spPr>
          <a:xfrm>
            <a:off x="2864520" y="3517920"/>
            <a:ext cx="525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fr-FR" sz="9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Insuli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55"/>
          <p:cNvSpPr/>
          <p:nvPr/>
        </p:nvSpPr>
        <p:spPr>
          <a:xfrm>
            <a:off x="3848040" y="3517920"/>
            <a:ext cx="485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fr-FR" sz="9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Merg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56"/>
          <p:cNvSpPr/>
          <p:nvPr/>
        </p:nvSpPr>
        <p:spPr>
          <a:xfrm>
            <a:off x="5303520" y="3517920"/>
            <a:ext cx="397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fr-FR" sz="9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CD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57"/>
          <p:cNvSpPr/>
          <p:nvPr/>
        </p:nvSpPr>
        <p:spPr>
          <a:xfrm>
            <a:off x="6306120" y="3517920"/>
            <a:ext cx="525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fr-FR" sz="9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Insuli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58"/>
          <p:cNvSpPr/>
          <p:nvPr/>
        </p:nvSpPr>
        <p:spPr>
          <a:xfrm>
            <a:off x="7346880" y="3517920"/>
            <a:ext cx="485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fr-FR" sz="9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Merg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4-06T08:18:16Z</dcterms:created>
  <dc:creator>Preferred Customer</dc:creator>
  <dc:description/>
  <dc:language>en-US</dc:language>
  <cp:lastModifiedBy>Sylvaine You</cp:lastModifiedBy>
  <cp:lastPrinted>2013-07-12T16:40:28Z</cp:lastPrinted>
  <dcterms:modified xsi:type="dcterms:W3CDTF">2013-08-08T12:39:16Z</dcterms:modified>
  <cp:revision>25</cp:revision>
  <dc:subject/>
  <dc:title>Diapositive 1</dc:title>
</cp:coreProperties>
</file>